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4788" y="1162050"/>
            <a:ext cx="40608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how similar information, except that these show the expression in both humanized and non-humanized sampl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22A78B4-7EA9-4D98-9F86-E18775CE8DC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92419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288723" y="608222"/>
            <a:ext cx="34809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0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529859" y="1618595"/>
            <a:ext cx="9378788" cy="4580418"/>
            <a:chOff x="529859" y="1618595"/>
            <a:chExt cx="9378788" cy="4580418"/>
          </a:xfrm>
        </p:grpSpPr>
        <p:grpSp>
          <p:nvGrpSpPr>
            <p:cNvPr id="17" name="Group 16"/>
            <p:cNvGrpSpPr/>
            <p:nvPr/>
          </p:nvGrpSpPr>
          <p:grpSpPr>
            <a:xfrm>
              <a:off x="529859" y="1618595"/>
              <a:ext cx="9378788" cy="4580418"/>
              <a:chOff x="529859" y="1618595"/>
              <a:chExt cx="9378788" cy="4580418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529859" y="1618595"/>
                <a:ext cx="9159086" cy="4580418"/>
                <a:chOff x="529859" y="1618595"/>
                <a:chExt cx="9159086" cy="4580418"/>
              </a:xfrm>
            </p:grpSpPr>
            <p:grpSp>
              <p:nvGrpSpPr>
                <p:cNvPr id="2" name="Group 1"/>
                <p:cNvGrpSpPr/>
                <p:nvPr/>
              </p:nvGrpSpPr>
              <p:grpSpPr>
                <a:xfrm>
                  <a:off x="529859" y="1618595"/>
                  <a:ext cx="8998683" cy="4580418"/>
                  <a:chOff x="529859" y="1618595"/>
                  <a:chExt cx="8998683" cy="4580418"/>
                </a:xfrm>
              </p:grpSpPr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0260" r="918" b="5018"/>
                  <a:stretch/>
                </p:blipFill>
                <p:spPr>
                  <a:xfrm>
                    <a:off x="529859" y="1870840"/>
                    <a:ext cx="8998683" cy="4328173"/>
                  </a:xfrm>
                  <a:prstGeom prst="rect">
                    <a:avLst/>
                  </a:prstGeom>
                </p:spPr>
              </p:pic>
              <p:sp>
                <p:nvSpPr>
                  <p:cNvPr id="6" name="TextBox 5"/>
                  <p:cNvSpPr txBox="1"/>
                  <p:nvPr/>
                </p:nvSpPr>
                <p:spPr>
                  <a:xfrm>
                    <a:off x="924911" y="1618595"/>
                    <a:ext cx="389933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4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HuNBSGW</a:t>
                    </a:r>
                    <a:r>
                      <a:rPr kumimoji="0" lang="en-US" sz="14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 Liver</a:t>
                    </a:r>
                  </a:p>
                </p:txBody>
              </p:sp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4855778" y="1622362"/>
                    <a:ext cx="39624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4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NBSGW </a:t>
                    </a:r>
                    <a:r>
                      <a:rPr kumimoji="0" lang="en-US" sz="14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Liver</a:t>
                    </a:r>
                  </a:p>
                </p:txBody>
              </p:sp>
            </p:grpSp>
            <p:sp>
              <p:nvSpPr>
                <p:cNvPr id="3" name="Rectangle 2"/>
                <p:cNvSpPr/>
                <p:nvPr/>
              </p:nvSpPr>
              <p:spPr>
                <a:xfrm>
                  <a:off x="9082424" y="3328170"/>
                  <a:ext cx="606521" cy="25861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9" name="TextBox 8"/>
              <p:cNvSpPr txBox="1"/>
              <p:nvPr/>
            </p:nvSpPr>
            <p:spPr>
              <a:xfrm>
                <a:off x="8996218" y="3272813"/>
                <a:ext cx="9124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HuNBSGW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liver</a:t>
                </a:r>
              </a:p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BSGW liver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860293" y="3697165"/>
                <a:ext cx="75533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xpression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9100427" y="3906320"/>
                <a:ext cx="286081" cy="69947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9015543" y="3854876"/>
                <a:ext cx="276037" cy="7591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1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</a:t>
                </a:r>
              </a:p>
              <a:p>
                <a:pPr marL="0" marR="0" lvl="0" indent="0" algn="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1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</a:t>
                </a:r>
              </a:p>
              <a:p>
                <a:pPr marL="0" marR="0" lvl="0" indent="0" algn="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1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</a:p>
              <a:p>
                <a:pPr marL="0" marR="0" lvl="0" indent="0" algn="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1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1</a:t>
                </a:r>
              </a:p>
              <a:p>
                <a:pPr marL="0" marR="0" lvl="0" indent="0" algn="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1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2</a:t>
                </a:r>
                <a:endPara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8921230" y="3171009"/>
                <a:ext cx="464661" cy="1488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8875278" y="3127279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dentity</a:t>
              </a:r>
              <a:endPara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19000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40</Words>
  <Application>Microsoft Office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23</cp:revision>
  <dcterms:created xsi:type="dcterms:W3CDTF">2024-11-19T17:14:58Z</dcterms:created>
  <dcterms:modified xsi:type="dcterms:W3CDTF">2024-11-19T17:48:50Z</dcterms:modified>
</cp:coreProperties>
</file>